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19" d="100"/>
          <a:sy n="119" d="100"/>
        </p:scale>
        <p:origin x="-208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LACIE%20SHARE:IL-18Rs%20MS:&#30707;&#21407;&#20808;&#29983;%20NFkB&#12289;IL-18R&#27963;&#24615;&#21270;&#29289;&#36074;&#25506;&#32034;(&#12498;&#12483;&#12488;&#28961;&#12375;):190220-IL18%20reporter%20cell%20TLR4%20ver-%20ishihara%201-1%20screening%201uM&#9675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LACIE%20SHARE:IL-18Rs%20MS:&#30707;&#21407;&#20808;&#29983;%20NFkB&#12289;IL-18R&#27963;&#24615;&#21270;&#29289;&#36074;&#25506;&#32034;(&#12498;&#12483;&#12488;&#28961;&#12375;):190220-IL18%20reporter%20cell%20TLR4%20ver-%20ishihara%201-1%20screening%201uM&#9675;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LACIE%20SHARE:IL-18Rs%20MS:&#30707;&#21407;&#20808;&#29983;%20NFkB&#12289;IL-18R&#27963;&#24615;&#21270;&#29289;&#36074;&#25506;&#32034;(&#12498;&#12483;&#12488;&#28961;&#12375;):190222-IL18%20reporter%20cell%20SEAP%20ver-%20ishihara%202-1%20screening%201uM&#9675;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LACIE%20SHARE:IL-18Rs%20MS:&#30707;&#21407;&#20808;&#29983;%20NFkB&#12289;IL-18R&#27963;&#24615;&#21270;&#29289;&#36074;&#25506;&#32034;(&#12498;&#12483;&#12488;&#28961;&#12375;):190222-IL18%20reporter%20cell%20SEAP%20ver-%20ishihara%202-1%20screening%201uM&#9675;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LACIE%20SHARE:IL-18Rs%20MS:&#30707;&#21407;&#20808;&#29983;%20NFkB&#12289;IL-18R&#27963;&#24615;&#21270;&#29289;&#36074;&#25506;&#32034;(&#12498;&#12483;&#12488;&#28961;&#12375;):190225-IL18%20reporter%20cell%20TLR4%20ver-%20ishihara%203-1%20screening%201uM&#9675;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LACIE%20SHARE:IL-18Rs%20MS:&#30707;&#21407;&#20808;&#29983;%20NFkB&#12289;IL-18R&#27963;&#24615;&#21270;&#29289;&#36074;&#25506;&#32034;(&#12498;&#12483;&#12488;&#28961;&#12375;):190225-IL18%20reporter%20cell%20TLR4%20ver-%20ishihara%203-1%20screening%201uM&#9675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47625">
              <a:noFill/>
            </a:ln>
          </c:spPr>
          <c:marker>
            <c:symbol val="circle"/>
            <c:size val="9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dPt>
            <c:idx val="0"/>
            <c:marker>
              <c:spPr>
                <a:solidFill>
                  <a:srgbClr val="3366FF"/>
                </a:solidFill>
                <a:ln>
                  <a:solidFill>
                    <a:schemeClr val="tx1"/>
                  </a:solidFill>
                </a:ln>
              </c:spPr>
            </c:marker>
            <c:bubble3D val="0"/>
          </c:dPt>
          <c:dPt>
            <c:idx val="81"/>
            <c:marker>
              <c:spPr>
                <a:solidFill>
                  <a:srgbClr val="FFFF00"/>
                </a:solidFill>
                <a:ln>
                  <a:solidFill>
                    <a:schemeClr val="tx1"/>
                  </a:solidFill>
                </a:ln>
              </c:spPr>
            </c:marker>
            <c:bubble3D val="0"/>
          </c:dPt>
          <c:yVal>
            <c:numRef>
              <c:f>Sheet3!$A$1:$CD$1</c:f>
              <c:numCache>
                <c:formatCode>General</c:formatCode>
                <c:ptCount val="82"/>
                <c:pt idx="0">
                  <c:v>8909.5</c:v>
                </c:pt>
                <c:pt idx="1">
                  <c:v>6080.0</c:v>
                </c:pt>
                <c:pt idx="2">
                  <c:v>5923.0</c:v>
                </c:pt>
                <c:pt idx="3">
                  <c:v>5948.0</c:v>
                </c:pt>
                <c:pt idx="4">
                  <c:v>6389.0</c:v>
                </c:pt>
                <c:pt idx="5">
                  <c:v>6114.0</c:v>
                </c:pt>
                <c:pt idx="6">
                  <c:v>5190.0</c:v>
                </c:pt>
                <c:pt idx="7">
                  <c:v>5633.0</c:v>
                </c:pt>
                <c:pt idx="8">
                  <c:v>6049.0</c:v>
                </c:pt>
                <c:pt idx="9">
                  <c:v>7173.0</c:v>
                </c:pt>
                <c:pt idx="10">
                  <c:v>8900.0</c:v>
                </c:pt>
                <c:pt idx="11">
                  <c:v>6120.0</c:v>
                </c:pt>
                <c:pt idx="12">
                  <c:v>5392.0</c:v>
                </c:pt>
                <c:pt idx="13">
                  <c:v>5583.0</c:v>
                </c:pt>
                <c:pt idx="14">
                  <c:v>4641.0</c:v>
                </c:pt>
                <c:pt idx="15">
                  <c:v>6422.0</c:v>
                </c:pt>
                <c:pt idx="16">
                  <c:v>5050.0</c:v>
                </c:pt>
                <c:pt idx="17">
                  <c:v>6158.0</c:v>
                </c:pt>
                <c:pt idx="18">
                  <c:v>4882.0</c:v>
                </c:pt>
                <c:pt idx="19">
                  <c:v>5920.0</c:v>
                </c:pt>
                <c:pt idx="20">
                  <c:v>9090.0</c:v>
                </c:pt>
                <c:pt idx="21">
                  <c:v>5150.0</c:v>
                </c:pt>
                <c:pt idx="22">
                  <c:v>4930.0</c:v>
                </c:pt>
                <c:pt idx="23">
                  <c:v>5491.0</c:v>
                </c:pt>
                <c:pt idx="24">
                  <c:v>5918.0</c:v>
                </c:pt>
                <c:pt idx="25">
                  <c:v>5579.0</c:v>
                </c:pt>
                <c:pt idx="26">
                  <c:v>5107.0</c:v>
                </c:pt>
                <c:pt idx="27">
                  <c:v>5901.0</c:v>
                </c:pt>
                <c:pt idx="28">
                  <c:v>5196.0</c:v>
                </c:pt>
                <c:pt idx="29">
                  <c:v>6042.0</c:v>
                </c:pt>
                <c:pt idx="30">
                  <c:v>9226.0</c:v>
                </c:pt>
                <c:pt idx="31">
                  <c:v>6496.0</c:v>
                </c:pt>
                <c:pt idx="32">
                  <c:v>5750.0</c:v>
                </c:pt>
                <c:pt idx="33">
                  <c:v>6111.0</c:v>
                </c:pt>
                <c:pt idx="34">
                  <c:v>6584.0</c:v>
                </c:pt>
                <c:pt idx="35">
                  <c:v>5566.0</c:v>
                </c:pt>
                <c:pt idx="36">
                  <c:v>5036.0</c:v>
                </c:pt>
                <c:pt idx="37">
                  <c:v>6137.0</c:v>
                </c:pt>
                <c:pt idx="38">
                  <c:v>5963.0</c:v>
                </c:pt>
                <c:pt idx="39">
                  <c:v>5710.0</c:v>
                </c:pt>
                <c:pt idx="40">
                  <c:v>9606.0</c:v>
                </c:pt>
                <c:pt idx="41">
                  <c:v>7909.0</c:v>
                </c:pt>
                <c:pt idx="42">
                  <c:v>6353.0</c:v>
                </c:pt>
                <c:pt idx="43">
                  <c:v>6143.0</c:v>
                </c:pt>
                <c:pt idx="44">
                  <c:v>5233.0</c:v>
                </c:pt>
                <c:pt idx="45">
                  <c:v>5686.0</c:v>
                </c:pt>
                <c:pt idx="46">
                  <c:v>6124.0</c:v>
                </c:pt>
                <c:pt idx="47">
                  <c:v>5445.0</c:v>
                </c:pt>
                <c:pt idx="48">
                  <c:v>5429.0</c:v>
                </c:pt>
                <c:pt idx="49">
                  <c:v>5880.0</c:v>
                </c:pt>
                <c:pt idx="50">
                  <c:v>5622.0</c:v>
                </c:pt>
                <c:pt idx="51">
                  <c:v>10046.0</c:v>
                </c:pt>
                <c:pt idx="52">
                  <c:v>6377.0</c:v>
                </c:pt>
                <c:pt idx="53">
                  <c:v>6209.0</c:v>
                </c:pt>
                <c:pt idx="54">
                  <c:v>10835.0</c:v>
                </c:pt>
                <c:pt idx="55">
                  <c:v>5970.0</c:v>
                </c:pt>
                <c:pt idx="56">
                  <c:v>6003.0</c:v>
                </c:pt>
                <c:pt idx="57">
                  <c:v>5914.0</c:v>
                </c:pt>
                <c:pt idx="58">
                  <c:v>6250.0</c:v>
                </c:pt>
                <c:pt idx="59">
                  <c:v>6344.0</c:v>
                </c:pt>
                <c:pt idx="60">
                  <c:v>6098.0</c:v>
                </c:pt>
                <c:pt idx="61">
                  <c:v>7028.0</c:v>
                </c:pt>
                <c:pt idx="62">
                  <c:v>5384.0</c:v>
                </c:pt>
                <c:pt idx="63">
                  <c:v>5619.0</c:v>
                </c:pt>
                <c:pt idx="64">
                  <c:v>6808.0</c:v>
                </c:pt>
                <c:pt idx="65">
                  <c:v>5987.0</c:v>
                </c:pt>
                <c:pt idx="66">
                  <c:v>5414.0</c:v>
                </c:pt>
                <c:pt idx="67">
                  <c:v>6116.0</c:v>
                </c:pt>
                <c:pt idx="68">
                  <c:v>5496.0</c:v>
                </c:pt>
                <c:pt idx="69">
                  <c:v>6582.0</c:v>
                </c:pt>
                <c:pt idx="70">
                  <c:v>5295.0</c:v>
                </c:pt>
                <c:pt idx="71">
                  <c:v>7737.0</c:v>
                </c:pt>
                <c:pt idx="72">
                  <c:v>5436.0</c:v>
                </c:pt>
                <c:pt idx="73">
                  <c:v>6833.0</c:v>
                </c:pt>
                <c:pt idx="74">
                  <c:v>7003.0</c:v>
                </c:pt>
                <c:pt idx="75">
                  <c:v>6483.0</c:v>
                </c:pt>
                <c:pt idx="76">
                  <c:v>8461.0</c:v>
                </c:pt>
                <c:pt idx="77">
                  <c:v>7094.0</c:v>
                </c:pt>
                <c:pt idx="78">
                  <c:v>6743.0</c:v>
                </c:pt>
                <c:pt idx="79">
                  <c:v>6867.0</c:v>
                </c:pt>
                <c:pt idx="80">
                  <c:v>5977.0</c:v>
                </c:pt>
                <c:pt idx="81">
                  <c:v>654429.7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42042056"/>
        <c:axId val="-2041877672"/>
      </c:scatterChart>
      <c:valAx>
        <c:axId val="-2042042056"/>
        <c:scaling>
          <c:orientation val="minMax"/>
          <c:max val="90.0"/>
          <c:min val="0.0"/>
        </c:scaling>
        <c:delete val="0"/>
        <c:axPos val="b"/>
        <c:majorTickMark val="out"/>
        <c:minorTickMark val="none"/>
        <c:tickLblPos val="nextTo"/>
        <c:crossAx val="-2041877672"/>
        <c:crosses val="autoZero"/>
        <c:crossBetween val="midCat"/>
        <c:majorUnit val="10.0"/>
      </c:valAx>
      <c:valAx>
        <c:axId val="-20418776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-2042042056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47625">
              <a:noFill/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dPt>
            <c:idx val="0"/>
            <c:marker>
              <c:spPr>
                <a:solidFill>
                  <a:srgbClr val="3366FF"/>
                </a:solidFill>
                <a:ln>
                  <a:solidFill>
                    <a:schemeClr val="tx1"/>
                  </a:solidFill>
                </a:ln>
              </c:spPr>
            </c:marker>
            <c:bubble3D val="0"/>
          </c:dPt>
          <c:dPt>
            <c:idx val="81"/>
            <c:marker>
              <c:spPr>
                <a:solidFill>
                  <a:srgbClr val="FFFF00"/>
                </a:solidFill>
                <a:ln>
                  <a:solidFill>
                    <a:schemeClr val="tx1"/>
                  </a:solidFill>
                </a:ln>
              </c:spPr>
            </c:marker>
            <c:bubble3D val="0"/>
          </c:dPt>
          <c:yVal>
            <c:numRef>
              <c:f>Sheet4!$A$1:$CD$1</c:f>
              <c:numCache>
                <c:formatCode>General</c:formatCode>
                <c:ptCount val="82"/>
                <c:pt idx="0" formatCode="0">
                  <c:v>8944.25</c:v>
                </c:pt>
                <c:pt idx="1">
                  <c:v>8221.0</c:v>
                </c:pt>
                <c:pt idx="2">
                  <c:v>8637.0</c:v>
                </c:pt>
                <c:pt idx="3">
                  <c:v>7812.0</c:v>
                </c:pt>
                <c:pt idx="4">
                  <c:v>5761.0</c:v>
                </c:pt>
                <c:pt idx="5">
                  <c:v>7197.0</c:v>
                </c:pt>
                <c:pt idx="6">
                  <c:v>7532.0</c:v>
                </c:pt>
                <c:pt idx="7">
                  <c:v>8053.0</c:v>
                </c:pt>
                <c:pt idx="8">
                  <c:v>7180.0</c:v>
                </c:pt>
                <c:pt idx="9">
                  <c:v>7782.0</c:v>
                </c:pt>
                <c:pt idx="10">
                  <c:v>10230.0</c:v>
                </c:pt>
                <c:pt idx="11">
                  <c:v>7311.0</c:v>
                </c:pt>
                <c:pt idx="12">
                  <c:v>7269.0</c:v>
                </c:pt>
                <c:pt idx="13">
                  <c:v>8403.0</c:v>
                </c:pt>
                <c:pt idx="14">
                  <c:v>7441.0</c:v>
                </c:pt>
                <c:pt idx="15">
                  <c:v>6830.0</c:v>
                </c:pt>
                <c:pt idx="16">
                  <c:v>8242.0</c:v>
                </c:pt>
                <c:pt idx="17">
                  <c:v>6788.0</c:v>
                </c:pt>
                <c:pt idx="18">
                  <c:v>7821.0</c:v>
                </c:pt>
                <c:pt idx="19">
                  <c:v>7359.0</c:v>
                </c:pt>
                <c:pt idx="20">
                  <c:v>9410.0</c:v>
                </c:pt>
                <c:pt idx="21">
                  <c:v>8082.0</c:v>
                </c:pt>
                <c:pt idx="22">
                  <c:v>7668.0</c:v>
                </c:pt>
                <c:pt idx="23">
                  <c:v>7135.0</c:v>
                </c:pt>
                <c:pt idx="24">
                  <c:v>6715.0</c:v>
                </c:pt>
                <c:pt idx="25">
                  <c:v>9746.0</c:v>
                </c:pt>
                <c:pt idx="26">
                  <c:v>7165.0</c:v>
                </c:pt>
                <c:pt idx="27">
                  <c:v>6013.0</c:v>
                </c:pt>
                <c:pt idx="28">
                  <c:v>8411.0</c:v>
                </c:pt>
                <c:pt idx="29">
                  <c:v>6977.0</c:v>
                </c:pt>
                <c:pt idx="30">
                  <c:v>10091.0</c:v>
                </c:pt>
                <c:pt idx="31">
                  <c:v>8878.0</c:v>
                </c:pt>
                <c:pt idx="32">
                  <c:v>8248.0</c:v>
                </c:pt>
                <c:pt idx="33">
                  <c:v>7859.0</c:v>
                </c:pt>
                <c:pt idx="34">
                  <c:v>7352.0</c:v>
                </c:pt>
                <c:pt idx="35">
                  <c:v>7421.0</c:v>
                </c:pt>
                <c:pt idx="36">
                  <c:v>7706.0</c:v>
                </c:pt>
                <c:pt idx="37">
                  <c:v>7158.0</c:v>
                </c:pt>
                <c:pt idx="38">
                  <c:v>7367.0</c:v>
                </c:pt>
                <c:pt idx="39">
                  <c:v>8643.0</c:v>
                </c:pt>
                <c:pt idx="40">
                  <c:v>10422.0</c:v>
                </c:pt>
                <c:pt idx="41">
                  <c:v>7235.0</c:v>
                </c:pt>
                <c:pt idx="42">
                  <c:v>7008.0</c:v>
                </c:pt>
                <c:pt idx="43">
                  <c:v>9099.0</c:v>
                </c:pt>
                <c:pt idx="44">
                  <c:v>8142.0</c:v>
                </c:pt>
                <c:pt idx="45">
                  <c:v>9446.0</c:v>
                </c:pt>
                <c:pt idx="46">
                  <c:v>6849.0</c:v>
                </c:pt>
                <c:pt idx="47">
                  <c:v>7626.0</c:v>
                </c:pt>
                <c:pt idx="48">
                  <c:v>8645.0</c:v>
                </c:pt>
                <c:pt idx="49">
                  <c:v>7611.0</c:v>
                </c:pt>
                <c:pt idx="50">
                  <c:v>7099.0</c:v>
                </c:pt>
                <c:pt idx="51">
                  <c:v>6975.0</c:v>
                </c:pt>
                <c:pt idx="52">
                  <c:v>8251.0</c:v>
                </c:pt>
                <c:pt idx="53">
                  <c:v>8735.0</c:v>
                </c:pt>
                <c:pt idx="54">
                  <c:v>8218.0</c:v>
                </c:pt>
                <c:pt idx="55">
                  <c:v>7466.0</c:v>
                </c:pt>
                <c:pt idx="56">
                  <c:v>7196.0</c:v>
                </c:pt>
                <c:pt idx="57">
                  <c:v>8672.0</c:v>
                </c:pt>
                <c:pt idx="58">
                  <c:v>9054.0</c:v>
                </c:pt>
                <c:pt idx="59">
                  <c:v>8175.0</c:v>
                </c:pt>
                <c:pt idx="60">
                  <c:v>7303.0</c:v>
                </c:pt>
                <c:pt idx="61">
                  <c:v>8868.0</c:v>
                </c:pt>
                <c:pt idx="62">
                  <c:v>7231.0</c:v>
                </c:pt>
                <c:pt idx="63">
                  <c:v>6971.0</c:v>
                </c:pt>
                <c:pt idx="64">
                  <c:v>8766.0</c:v>
                </c:pt>
                <c:pt idx="65">
                  <c:v>6812.0</c:v>
                </c:pt>
                <c:pt idx="66">
                  <c:v>8134.0</c:v>
                </c:pt>
                <c:pt idx="67">
                  <c:v>8312.0</c:v>
                </c:pt>
                <c:pt idx="68">
                  <c:v>7885.0</c:v>
                </c:pt>
                <c:pt idx="69">
                  <c:v>7238.0</c:v>
                </c:pt>
                <c:pt idx="70">
                  <c:v>8652.0</c:v>
                </c:pt>
                <c:pt idx="71">
                  <c:v>5989.0</c:v>
                </c:pt>
                <c:pt idx="72">
                  <c:v>4973.0</c:v>
                </c:pt>
                <c:pt idx="73">
                  <c:v>8306.0</c:v>
                </c:pt>
                <c:pt idx="74">
                  <c:v>5406.0</c:v>
                </c:pt>
                <c:pt idx="75">
                  <c:v>7749.0</c:v>
                </c:pt>
                <c:pt idx="76">
                  <c:v>6655.0</c:v>
                </c:pt>
                <c:pt idx="77">
                  <c:v>7417.0</c:v>
                </c:pt>
                <c:pt idx="78">
                  <c:v>6738.0</c:v>
                </c:pt>
                <c:pt idx="79">
                  <c:v>6384.0</c:v>
                </c:pt>
                <c:pt idx="80">
                  <c:v>7089.0</c:v>
                </c:pt>
                <c:pt idx="81" formatCode="0">
                  <c:v>1.6525E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15072808"/>
        <c:axId val="-2115691640"/>
      </c:scatterChart>
      <c:valAx>
        <c:axId val="-2115072808"/>
        <c:scaling>
          <c:orientation val="minMax"/>
        </c:scaling>
        <c:delete val="0"/>
        <c:axPos val="b"/>
        <c:majorTickMark val="out"/>
        <c:minorTickMark val="none"/>
        <c:tickLblPos val="nextTo"/>
        <c:crossAx val="-2115691640"/>
        <c:crosses val="autoZero"/>
        <c:crossBetween val="midCat"/>
      </c:valAx>
      <c:valAx>
        <c:axId val="-2115691640"/>
        <c:scaling>
          <c:orientation val="minMax"/>
        </c:scaling>
        <c:delete val="0"/>
        <c:axPos val="l"/>
        <c:numFmt formatCode="0" sourceLinked="1"/>
        <c:majorTickMark val="out"/>
        <c:minorTickMark val="none"/>
        <c:tickLblPos val="nextTo"/>
        <c:crossAx val="-2115072808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47625">
              <a:noFill/>
            </a:ln>
          </c:spPr>
          <c:marker>
            <c:symbol val="circle"/>
            <c:size val="9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dPt>
            <c:idx val="0"/>
            <c:marker>
              <c:spPr>
                <a:solidFill>
                  <a:srgbClr val="3366FF"/>
                </a:solidFill>
                <a:ln>
                  <a:solidFill>
                    <a:schemeClr val="tx1"/>
                  </a:solidFill>
                </a:ln>
              </c:spPr>
            </c:marker>
            <c:bubble3D val="0"/>
          </c:dPt>
          <c:dPt>
            <c:idx val="81"/>
            <c:marker>
              <c:spPr>
                <a:solidFill>
                  <a:srgbClr val="FFFF00"/>
                </a:solidFill>
                <a:ln>
                  <a:solidFill>
                    <a:schemeClr val="tx1"/>
                  </a:solidFill>
                </a:ln>
              </c:spPr>
            </c:marker>
            <c:bubble3D val="0"/>
          </c:dPt>
          <c:yVal>
            <c:numRef>
              <c:f>Sheet2!$A$1:$CD$1</c:f>
              <c:numCache>
                <c:formatCode>General</c:formatCode>
                <c:ptCount val="82"/>
                <c:pt idx="0">
                  <c:v>27348.5</c:v>
                </c:pt>
                <c:pt idx="1">
                  <c:v>21852.0</c:v>
                </c:pt>
                <c:pt idx="2">
                  <c:v>25426.0</c:v>
                </c:pt>
                <c:pt idx="3">
                  <c:v>21217.0</c:v>
                </c:pt>
                <c:pt idx="4">
                  <c:v>23081.0</c:v>
                </c:pt>
                <c:pt idx="5">
                  <c:v>22088.0</c:v>
                </c:pt>
                <c:pt idx="6">
                  <c:v>21031.0</c:v>
                </c:pt>
                <c:pt idx="7">
                  <c:v>22139.0</c:v>
                </c:pt>
                <c:pt idx="8">
                  <c:v>21937.0</c:v>
                </c:pt>
                <c:pt idx="9">
                  <c:v>18985.0</c:v>
                </c:pt>
                <c:pt idx="10">
                  <c:v>23301.0</c:v>
                </c:pt>
                <c:pt idx="11">
                  <c:v>22892.0</c:v>
                </c:pt>
                <c:pt idx="12">
                  <c:v>18024.0</c:v>
                </c:pt>
                <c:pt idx="13">
                  <c:v>23120.0</c:v>
                </c:pt>
                <c:pt idx="14">
                  <c:v>20402.0</c:v>
                </c:pt>
                <c:pt idx="15">
                  <c:v>23312.0</c:v>
                </c:pt>
                <c:pt idx="16">
                  <c:v>22206.0</c:v>
                </c:pt>
                <c:pt idx="17">
                  <c:v>18435.0</c:v>
                </c:pt>
                <c:pt idx="18">
                  <c:v>20531.0</c:v>
                </c:pt>
                <c:pt idx="19">
                  <c:v>18903.0</c:v>
                </c:pt>
                <c:pt idx="20">
                  <c:v>22843.0</c:v>
                </c:pt>
                <c:pt idx="21">
                  <c:v>21696.0</c:v>
                </c:pt>
                <c:pt idx="22">
                  <c:v>24015.0</c:v>
                </c:pt>
                <c:pt idx="23">
                  <c:v>17268.0</c:v>
                </c:pt>
                <c:pt idx="24">
                  <c:v>20633.0</c:v>
                </c:pt>
                <c:pt idx="25">
                  <c:v>19952.0</c:v>
                </c:pt>
                <c:pt idx="26">
                  <c:v>19194.0</c:v>
                </c:pt>
                <c:pt idx="27">
                  <c:v>20793.0</c:v>
                </c:pt>
                <c:pt idx="28">
                  <c:v>20269.0</c:v>
                </c:pt>
                <c:pt idx="29">
                  <c:v>21747.0</c:v>
                </c:pt>
                <c:pt idx="30">
                  <c:v>20834.0</c:v>
                </c:pt>
                <c:pt idx="31">
                  <c:v>24469.0</c:v>
                </c:pt>
                <c:pt idx="32">
                  <c:v>23950.0</c:v>
                </c:pt>
                <c:pt idx="33">
                  <c:v>21314.0</c:v>
                </c:pt>
                <c:pt idx="34">
                  <c:v>19686.0</c:v>
                </c:pt>
                <c:pt idx="35">
                  <c:v>21243.0</c:v>
                </c:pt>
                <c:pt idx="36">
                  <c:v>21897.0</c:v>
                </c:pt>
                <c:pt idx="37">
                  <c:v>20206.0</c:v>
                </c:pt>
                <c:pt idx="38">
                  <c:v>20659.0</c:v>
                </c:pt>
                <c:pt idx="39">
                  <c:v>19856.0</c:v>
                </c:pt>
                <c:pt idx="40">
                  <c:v>23796.0</c:v>
                </c:pt>
                <c:pt idx="41">
                  <c:v>24311.0</c:v>
                </c:pt>
                <c:pt idx="42">
                  <c:v>20016.0</c:v>
                </c:pt>
                <c:pt idx="43">
                  <c:v>20915.0</c:v>
                </c:pt>
                <c:pt idx="44">
                  <c:v>18859.0</c:v>
                </c:pt>
                <c:pt idx="45">
                  <c:v>20112.0</c:v>
                </c:pt>
                <c:pt idx="46">
                  <c:v>18398.0</c:v>
                </c:pt>
                <c:pt idx="47">
                  <c:v>22029.0</c:v>
                </c:pt>
                <c:pt idx="48">
                  <c:v>21291.0</c:v>
                </c:pt>
                <c:pt idx="49">
                  <c:v>18499.0</c:v>
                </c:pt>
                <c:pt idx="50">
                  <c:v>18694.0</c:v>
                </c:pt>
                <c:pt idx="51">
                  <c:v>22987.0</c:v>
                </c:pt>
                <c:pt idx="52">
                  <c:v>19497.0</c:v>
                </c:pt>
                <c:pt idx="53">
                  <c:v>20886.0</c:v>
                </c:pt>
                <c:pt idx="54">
                  <c:v>20332.0</c:v>
                </c:pt>
                <c:pt idx="55">
                  <c:v>21211.0</c:v>
                </c:pt>
                <c:pt idx="56">
                  <c:v>20338.0</c:v>
                </c:pt>
                <c:pt idx="57">
                  <c:v>20662.0</c:v>
                </c:pt>
                <c:pt idx="58">
                  <c:v>22500.0</c:v>
                </c:pt>
                <c:pt idx="59">
                  <c:v>22390.0</c:v>
                </c:pt>
                <c:pt idx="60">
                  <c:v>19247.0</c:v>
                </c:pt>
                <c:pt idx="61">
                  <c:v>25019.0</c:v>
                </c:pt>
                <c:pt idx="62">
                  <c:v>21058.0</c:v>
                </c:pt>
                <c:pt idx="63">
                  <c:v>20306.0</c:v>
                </c:pt>
                <c:pt idx="64">
                  <c:v>22751.0</c:v>
                </c:pt>
                <c:pt idx="65">
                  <c:v>20100.0</c:v>
                </c:pt>
                <c:pt idx="66">
                  <c:v>19563.0</c:v>
                </c:pt>
                <c:pt idx="67">
                  <c:v>18400.0</c:v>
                </c:pt>
                <c:pt idx="68">
                  <c:v>19016.0</c:v>
                </c:pt>
                <c:pt idx="69">
                  <c:v>18688.0</c:v>
                </c:pt>
                <c:pt idx="70">
                  <c:v>18957.0</c:v>
                </c:pt>
                <c:pt idx="71">
                  <c:v>21285.0</c:v>
                </c:pt>
                <c:pt idx="72">
                  <c:v>20834.0</c:v>
                </c:pt>
                <c:pt idx="73">
                  <c:v>21699.0</c:v>
                </c:pt>
                <c:pt idx="74">
                  <c:v>21134.0</c:v>
                </c:pt>
                <c:pt idx="75">
                  <c:v>21029.0</c:v>
                </c:pt>
                <c:pt idx="76">
                  <c:v>21848.0</c:v>
                </c:pt>
                <c:pt idx="77">
                  <c:v>16458.0</c:v>
                </c:pt>
                <c:pt idx="78">
                  <c:v>18978.0</c:v>
                </c:pt>
                <c:pt idx="79">
                  <c:v>16828.0</c:v>
                </c:pt>
                <c:pt idx="80">
                  <c:v>21659.0</c:v>
                </c:pt>
                <c:pt idx="81">
                  <c:v>501705.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45202568"/>
        <c:axId val="-2045145448"/>
      </c:scatterChart>
      <c:valAx>
        <c:axId val="-2045202568"/>
        <c:scaling>
          <c:orientation val="minMax"/>
          <c:max val="90.0"/>
          <c:min val="0.0"/>
        </c:scaling>
        <c:delete val="0"/>
        <c:axPos val="b"/>
        <c:majorTickMark val="out"/>
        <c:minorTickMark val="none"/>
        <c:tickLblPos val="nextTo"/>
        <c:crossAx val="-2045145448"/>
        <c:crosses val="autoZero"/>
        <c:crossBetween val="midCat"/>
        <c:majorUnit val="10.0"/>
      </c:valAx>
      <c:valAx>
        <c:axId val="-20451454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-2045202568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47625">
              <a:noFill/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dPt>
            <c:idx val="0"/>
            <c:marker>
              <c:spPr>
                <a:solidFill>
                  <a:srgbClr val="3366FF"/>
                </a:solidFill>
                <a:ln>
                  <a:solidFill>
                    <a:schemeClr val="tx1"/>
                  </a:solidFill>
                </a:ln>
              </c:spPr>
            </c:marker>
            <c:bubble3D val="0"/>
          </c:dPt>
          <c:dPt>
            <c:idx val="81"/>
            <c:marker>
              <c:spPr>
                <a:solidFill>
                  <a:srgbClr val="FFFF00"/>
                </a:solidFill>
                <a:ln>
                  <a:solidFill>
                    <a:schemeClr val="tx1"/>
                  </a:solidFill>
                </a:ln>
              </c:spPr>
            </c:marker>
            <c:bubble3D val="0"/>
          </c:dPt>
          <c:yVal>
            <c:numRef>
              <c:f>Sheet3!$A$1:$CD$1</c:f>
              <c:numCache>
                <c:formatCode>General</c:formatCode>
                <c:ptCount val="82"/>
                <c:pt idx="0" formatCode="0">
                  <c:v>18904.0</c:v>
                </c:pt>
                <c:pt idx="1">
                  <c:v>18600.0</c:v>
                </c:pt>
                <c:pt idx="2">
                  <c:v>20470.0</c:v>
                </c:pt>
                <c:pt idx="3">
                  <c:v>18287.0</c:v>
                </c:pt>
                <c:pt idx="4">
                  <c:v>19791.0</c:v>
                </c:pt>
                <c:pt idx="5">
                  <c:v>18531.0</c:v>
                </c:pt>
                <c:pt idx="6">
                  <c:v>17888.0</c:v>
                </c:pt>
                <c:pt idx="7">
                  <c:v>21448.0</c:v>
                </c:pt>
                <c:pt idx="8">
                  <c:v>16343.0</c:v>
                </c:pt>
                <c:pt idx="9">
                  <c:v>20200.0</c:v>
                </c:pt>
                <c:pt idx="10">
                  <c:v>22709.0</c:v>
                </c:pt>
                <c:pt idx="11">
                  <c:v>18654.0</c:v>
                </c:pt>
                <c:pt idx="12">
                  <c:v>21171.0</c:v>
                </c:pt>
                <c:pt idx="13">
                  <c:v>20206.0</c:v>
                </c:pt>
                <c:pt idx="14">
                  <c:v>18473.0</c:v>
                </c:pt>
                <c:pt idx="15">
                  <c:v>19893.0</c:v>
                </c:pt>
                <c:pt idx="16">
                  <c:v>17039.0</c:v>
                </c:pt>
                <c:pt idx="17">
                  <c:v>18475.0</c:v>
                </c:pt>
                <c:pt idx="18">
                  <c:v>20475.0</c:v>
                </c:pt>
                <c:pt idx="19">
                  <c:v>19322.0</c:v>
                </c:pt>
                <c:pt idx="20">
                  <c:v>19278.0</c:v>
                </c:pt>
                <c:pt idx="21">
                  <c:v>9207.0</c:v>
                </c:pt>
                <c:pt idx="22">
                  <c:v>19296.0</c:v>
                </c:pt>
                <c:pt idx="23">
                  <c:v>18059.0</c:v>
                </c:pt>
                <c:pt idx="24">
                  <c:v>18907.0</c:v>
                </c:pt>
                <c:pt idx="25">
                  <c:v>17310.0</c:v>
                </c:pt>
                <c:pt idx="26">
                  <c:v>16485.0</c:v>
                </c:pt>
                <c:pt idx="27">
                  <c:v>17501.0</c:v>
                </c:pt>
                <c:pt idx="28">
                  <c:v>17483.0</c:v>
                </c:pt>
                <c:pt idx="29">
                  <c:v>18368.0</c:v>
                </c:pt>
                <c:pt idx="30">
                  <c:v>21654.0</c:v>
                </c:pt>
                <c:pt idx="31">
                  <c:v>16177.0</c:v>
                </c:pt>
                <c:pt idx="32">
                  <c:v>18479.0</c:v>
                </c:pt>
                <c:pt idx="33">
                  <c:v>18846.0</c:v>
                </c:pt>
                <c:pt idx="34">
                  <c:v>17978.0</c:v>
                </c:pt>
                <c:pt idx="35">
                  <c:v>17778.0</c:v>
                </c:pt>
                <c:pt idx="36">
                  <c:v>17583.0</c:v>
                </c:pt>
                <c:pt idx="37">
                  <c:v>21086.0</c:v>
                </c:pt>
                <c:pt idx="38">
                  <c:v>18673.0</c:v>
                </c:pt>
                <c:pt idx="39">
                  <c:v>17391.0</c:v>
                </c:pt>
                <c:pt idx="40">
                  <c:v>20418.0</c:v>
                </c:pt>
                <c:pt idx="41">
                  <c:v>18911.0</c:v>
                </c:pt>
                <c:pt idx="42">
                  <c:v>19261.0</c:v>
                </c:pt>
                <c:pt idx="43">
                  <c:v>17948.0</c:v>
                </c:pt>
                <c:pt idx="44">
                  <c:v>16781.0</c:v>
                </c:pt>
                <c:pt idx="45">
                  <c:v>20302.0</c:v>
                </c:pt>
                <c:pt idx="46">
                  <c:v>15657.0</c:v>
                </c:pt>
                <c:pt idx="47">
                  <c:v>17236.0</c:v>
                </c:pt>
                <c:pt idx="48">
                  <c:v>17028.0</c:v>
                </c:pt>
                <c:pt idx="49">
                  <c:v>19265.0</c:v>
                </c:pt>
                <c:pt idx="50">
                  <c:v>17752.0</c:v>
                </c:pt>
                <c:pt idx="51">
                  <c:v>19993.0</c:v>
                </c:pt>
                <c:pt idx="52">
                  <c:v>19955.0</c:v>
                </c:pt>
                <c:pt idx="53">
                  <c:v>18731.0</c:v>
                </c:pt>
                <c:pt idx="54">
                  <c:v>18031.0</c:v>
                </c:pt>
                <c:pt idx="55">
                  <c:v>17829.0</c:v>
                </c:pt>
                <c:pt idx="56">
                  <c:v>16637.0</c:v>
                </c:pt>
                <c:pt idx="57">
                  <c:v>18519.0</c:v>
                </c:pt>
                <c:pt idx="58">
                  <c:v>18539.0</c:v>
                </c:pt>
                <c:pt idx="59">
                  <c:v>16522.0</c:v>
                </c:pt>
                <c:pt idx="60">
                  <c:v>17768.0</c:v>
                </c:pt>
                <c:pt idx="61">
                  <c:v>18968.0</c:v>
                </c:pt>
                <c:pt idx="62">
                  <c:v>18147.0</c:v>
                </c:pt>
                <c:pt idx="63">
                  <c:v>16328.0</c:v>
                </c:pt>
                <c:pt idx="64">
                  <c:v>16880.0</c:v>
                </c:pt>
                <c:pt idx="65">
                  <c:v>19539.0</c:v>
                </c:pt>
                <c:pt idx="66">
                  <c:v>17925.0</c:v>
                </c:pt>
                <c:pt idx="67">
                  <c:v>16414.0</c:v>
                </c:pt>
                <c:pt idx="68">
                  <c:v>17175.0</c:v>
                </c:pt>
                <c:pt idx="69">
                  <c:v>19790.0</c:v>
                </c:pt>
                <c:pt idx="70">
                  <c:v>19058.0</c:v>
                </c:pt>
                <c:pt idx="71">
                  <c:v>20217.0</c:v>
                </c:pt>
                <c:pt idx="72">
                  <c:v>14687.0</c:v>
                </c:pt>
                <c:pt idx="73">
                  <c:v>20687.0</c:v>
                </c:pt>
                <c:pt idx="74">
                  <c:v>15343.0</c:v>
                </c:pt>
                <c:pt idx="75">
                  <c:v>20656.0</c:v>
                </c:pt>
                <c:pt idx="76">
                  <c:v>17779.0</c:v>
                </c:pt>
                <c:pt idx="77">
                  <c:v>18992.0</c:v>
                </c:pt>
                <c:pt idx="78">
                  <c:v>19781.0</c:v>
                </c:pt>
                <c:pt idx="79">
                  <c:v>19240.0</c:v>
                </c:pt>
                <c:pt idx="80">
                  <c:v>22415.0</c:v>
                </c:pt>
                <c:pt idx="81" formatCode="0">
                  <c:v>1.78925E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29167848"/>
        <c:axId val="-2029164920"/>
      </c:scatterChart>
      <c:valAx>
        <c:axId val="-2029167848"/>
        <c:scaling>
          <c:orientation val="minMax"/>
        </c:scaling>
        <c:delete val="0"/>
        <c:axPos val="b"/>
        <c:majorTickMark val="out"/>
        <c:minorTickMark val="none"/>
        <c:tickLblPos val="nextTo"/>
        <c:crossAx val="-2029164920"/>
        <c:crosses val="autoZero"/>
        <c:crossBetween val="midCat"/>
      </c:valAx>
      <c:valAx>
        <c:axId val="-2029164920"/>
        <c:scaling>
          <c:orientation val="minMax"/>
        </c:scaling>
        <c:delete val="0"/>
        <c:axPos val="l"/>
        <c:numFmt formatCode="0" sourceLinked="1"/>
        <c:majorTickMark val="out"/>
        <c:minorTickMark val="none"/>
        <c:tickLblPos val="nextTo"/>
        <c:crossAx val="-2029167848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4709109614512"/>
          <c:y val="0.0759874222636243"/>
          <c:w val="0.797150375460472"/>
          <c:h val="0.775856895110663"/>
        </c:manualLayout>
      </c:layout>
      <c:scatterChart>
        <c:scatterStyle val="lineMarker"/>
        <c:varyColors val="0"/>
        <c:ser>
          <c:idx val="0"/>
          <c:order val="0"/>
          <c:spPr>
            <a:ln w="47625">
              <a:noFill/>
            </a:ln>
          </c:spPr>
          <c:marker>
            <c:symbol val="circle"/>
            <c:size val="9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dPt>
            <c:idx val="0"/>
            <c:marker>
              <c:spPr>
                <a:solidFill>
                  <a:srgbClr val="3366FF"/>
                </a:solidFill>
                <a:ln>
                  <a:solidFill>
                    <a:schemeClr val="tx1"/>
                  </a:solidFill>
                </a:ln>
              </c:spPr>
            </c:marker>
            <c:bubble3D val="0"/>
          </c:dPt>
          <c:dPt>
            <c:idx val="81"/>
            <c:marker>
              <c:spPr>
                <a:solidFill>
                  <a:srgbClr val="FFFF00"/>
                </a:solidFill>
                <a:ln>
                  <a:solidFill>
                    <a:schemeClr val="tx1"/>
                  </a:solidFill>
                </a:ln>
              </c:spPr>
            </c:marker>
            <c:bubble3D val="0"/>
          </c:dPt>
          <c:yVal>
            <c:numRef>
              <c:f>Sheet4!$A$1:$CD$1</c:f>
              <c:numCache>
                <c:formatCode>General</c:formatCode>
                <c:ptCount val="82"/>
                <c:pt idx="0" formatCode="0">
                  <c:v>7840.5</c:v>
                </c:pt>
                <c:pt idx="1">
                  <c:v>4157.0</c:v>
                </c:pt>
                <c:pt idx="2">
                  <c:v>4051.0</c:v>
                </c:pt>
                <c:pt idx="3">
                  <c:v>3050.0</c:v>
                </c:pt>
                <c:pt idx="4">
                  <c:v>4399.0</c:v>
                </c:pt>
                <c:pt idx="5">
                  <c:v>3608.0</c:v>
                </c:pt>
                <c:pt idx="6">
                  <c:v>4513.0</c:v>
                </c:pt>
                <c:pt idx="7">
                  <c:v>4439.0</c:v>
                </c:pt>
                <c:pt idx="8">
                  <c:v>3648.0</c:v>
                </c:pt>
                <c:pt idx="9">
                  <c:v>4330.0</c:v>
                </c:pt>
                <c:pt idx="10">
                  <c:v>6592.0</c:v>
                </c:pt>
                <c:pt idx="11">
                  <c:v>4416.0</c:v>
                </c:pt>
                <c:pt idx="12">
                  <c:v>3212.0</c:v>
                </c:pt>
                <c:pt idx="13">
                  <c:v>3169.0</c:v>
                </c:pt>
                <c:pt idx="14">
                  <c:v>3486.0</c:v>
                </c:pt>
                <c:pt idx="15">
                  <c:v>3348.0</c:v>
                </c:pt>
                <c:pt idx="16">
                  <c:v>3685.0</c:v>
                </c:pt>
                <c:pt idx="17">
                  <c:v>4456.0</c:v>
                </c:pt>
                <c:pt idx="18">
                  <c:v>3196.0</c:v>
                </c:pt>
                <c:pt idx="19">
                  <c:v>3858.0</c:v>
                </c:pt>
                <c:pt idx="20">
                  <c:v>5425.0</c:v>
                </c:pt>
                <c:pt idx="21">
                  <c:v>3788.0</c:v>
                </c:pt>
                <c:pt idx="22">
                  <c:v>3877.0</c:v>
                </c:pt>
                <c:pt idx="23">
                  <c:v>3239.0</c:v>
                </c:pt>
                <c:pt idx="24">
                  <c:v>3724.0</c:v>
                </c:pt>
                <c:pt idx="25">
                  <c:v>3277.0</c:v>
                </c:pt>
                <c:pt idx="26">
                  <c:v>3246.0</c:v>
                </c:pt>
                <c:pt idx="27">
                  <c:v>3044.0</c:v>
                </c:pt>
                <c:pt idx="28">
                  <c:v>3806.0</c:v>
                </c:pt>
                <c:pt idx="29">
                  <c:v>3763.0</c:v>
                </c:pt>
                <c:pt idx="30">
                  <c:v>5463.0</c:v>
                </c:pt>
                <c:pt idx="31">
                  <c:v>3482.0</c:v>
                </c:pt>
                <c:pt idx="32">
                  <c:v>3770.0</c:v>
                </c:pt>
                <c:pt idx="33">
                  <c:v>3284.0</c:v>
                </c:pt>
                <c:pt idx="34">
                  <c:v>4014.0</c:v>
                </c:pt>
                <c:pt idx="35">
                  <c:v>3327.0</c:v>
                </c:pt>
                <c:pt idx="36">
                  <c:v>3666.0</c:v>
                </c:pt>
                <c:pt idx="37">
                  <c:v>3108.0</c:v>
                </c:pt>
                <c:pt idx="38">
                  <c:v>3103.0</c:v>
                </c:pt>
                <c:pt idx="39">
                  <c:v>3982.0</c:v>
                </c:pt>
                <c:pt idx="40">
                  <c:v>5710.0</c:v>
                </c:pt>
                <c:pt idx="41">
                  <c:v>3642.0</c:v>
                </c:pt>
                <c:pt idx="42">
                  <c:v>3307.0</c:v>
                </c:pt>
                <c:pt idx="43">
                  <c:v>3187.0</c:v>
                </c:pt>
                <c:pt idx="44">
                  <c:v>3600.0</c:v>
                </c:pt>
                <c:pt idx="45">
                  <c:v>3818.0</c:v>
                </c:pt>
                <c:pt idx="46">
                  <c:v>3255.0</c:v>
                </c:pt>
                <c:pt idx="47">
                  <c:v>3026.0</c:v>
                </c:pt>
                <c:pt idx="48">
                  <c:v>3243.0</c:v>
                </c:pt>
                <c:pt idx="49">
                  <c:v>2783.0</c:v>
                </c:pt>
                <c:pt idx="50">
                  <c:v>3449.0</c:v>
                </c:pt>
                <c:pt idx="51">
                  <c:v>4779.0</c:v>
                </c:pt>
                <c:pt idx="52">
                  <c:v>4049.0</c:v>
                </c:pt>
                <c:pt idx="53">
                  <c:v>2871.0</c:v>
                </c:pt>
                <c:pt idx="54">
                  <c:v>3283.0</c:v>
                </c:pt>
                <c:pt idx="55">
                  <c:v>3308.0</c:v>
                </c:pt>
                <c:pt idx="56">
                  <c:v>3712.0</c:v>
                </c:pt>
                <c:pt idx="57">
                  <c:v>3378.0</c:v>
                </c:pt>
                <c:pt idx="58">
                  <c:v>3743.0</c:v>
                </c:pt>
                <c:pt idx="59">
                  <c:v>3703.0</c:v>
                </c:pt>
                <c:pt idx="60">
                  <c:v>3278.0</c:v>
                </c:pt>
                <c:pt idx="61">
                  <c:v>4253.0</c:v>
                </c:pt>
                <c:pt idx="62">
                  <c:v>3077.0</c:v>
                </c:pt>
                <c:pt idx="63">
                  <c:v>2996.0</c:v>
                </c:pt>
                <c:pt idx="64">
                  <c:v>4112.0</c:v>
                </c:pt>
                <c:pt idx="65">
                  <c:v>3104.0</c:v>
                </c:pt>
                <c:pt idx="66">
                  <c:v>3578.0</c:v>
                </c:pt>
                <c:pt idx="67">
                  <c:v>3281.0</c:v>
                </c:pt>
                <c:pt idx="68">
                  <c:v>2941.0</c:v>
                </c:pt>
                <c:pt idx="69">
                  <c:v>3701.0</c:v>
                </c:pt>
                <c:pt idx="70">
                  <c:v>3789.0</c:v>
                </c:pt>
                <c:pt idx="71">
                  <c:v>6513.0</c:v>
                </c:pt>
                <c:pt idx="72">
                  <c:v>3433.0</c:v>
                </c:pt>
                <c:pt idx="73">
                  <c:v>3309.0</c:v>
                </c:pt>
                <c:pt idx="74">
                  <c:v>3824.0</c:v>
                </c:pt>
                <c:pt idx="75">
                  <c:v>3540.0</c:v>
                </c:pt>
                <c:pt idx="76">
                  <c:v>4010.0</c:v>
                </c:pt>
                <c:pt idx="77">
                  <c:v>3307.0</c:v>
                </c:pt>
                <c:pt idx="78">
                  <c:v>3363.0</c:v>
                </c:pt>
                <c:pt idx="79">
                  <c:v>3829.0</c:v>
                </c:pt>
                <c:pt idx="80">
                  <c:v>4659.0</c:v>
                </c:pt>
                <c:pt idx="81" formatCode="0">
                  <c:v>509712.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15959560"/>
        <c:axId val="-2088024408"/>
      </c:scatterChart>
      <c:valAx>
        <c:axId val="-2115959560"/>
        <c:scaling>
          <c:orientation val="minMax"/>
          <c:max val="90.0"/>
          <c:min val="0.0"/>
        </c:scaling>
        <c:delete val="0"/>
        <c:axPos val="b"/>
        <c:majorTickMark val="out"/>
        <c:minorTickMark val="none"/>
        <c:tickLblPos val="nextTo"/>
        <c:crossAx val="-2088024408"/>
        <c:crosses val="autoZero"/>
        <c:crossBetween val="midCat"/>
        <c:majorUnit val="10.0"/>
      </c:valAx>
      <c:valAx>
        <c:axId val="-2088024408"/>
        <c:scaling>
          <c:orientation val="minMax"/>
        </c:scaling>
        <c:delete val="0"/>
        <c:axPos val="l"/>
        <c:numFmt formatCode="0" sourceLinked="1"/>
        <c:majorTickMark val="out"/>
        <c:minorTickMark val="none"/>
        <c:tickLblPos val="nextTo"/>
        <c:crossAx val="-2115959560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47625">
              <a:noFill/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dPt>
            <c:idx val="0"/>
            <c:marker>
              <c:spPr>
                <a:solidFill>
                  <a:srgbClr val="3366FF"/>
                </a:solidFill>
                <a:ln>
                  <a:solidFill>
                    <a:schemeClr val="tx1"/>
                  </a:solidFill>
                </a:ln>
              </c:spPr>
            </c:marker>
            <c:bubble3D val="0"/>
          </c:dPt>
          <c:dPt>
            <c:idx val="81"/>
            <c:marker>
              <c:spPr>
                <a:solidFill>
                  <a:srgbClr val="FFFF00"/>
                </a:solidFill>
                <a:ln>
                  <a:solidFill>
                    <a:schemeClr val="tx1"/>
                  </a:solidFill>
                </a:ln>
              </c:spPr>
            </c:marker>
            <c:bubble3D val="0"/>
          </c:dPt>
          <c:yVal>
            <c:numRef>
              <c:f>Sheet5!$A$1:$CD$1</c:f>
              <c:numCache>
                <c:formatCode>General</c:formatCode>
                <c:ptCount val="82"/>
                <c:pt idx="0" formatCode="0">
                  <c:v>3267.5</c:v>
                </c:pt>
                <c:pt idx="1">
                  <c:v>3898.0</c:v>
                </c:pt>
                <c:pt idx="2">
                  <c:v>5252.0</c:v>
                </c:pt>
                <c:pt idx="3">
                  <c:v>3877.0</c:v>
                </c:pt>
                <c:pt idx="4">
                  <c:v>5136.0</c:v>
                </c:pt>
                <c:pt idx="5">
                  <c:v>4441.0</c:v>
                </c:pt>
                <c:pt idx="6">
                  <c:v>4129.0</c:v>
                </c:pt>
                <c:pt idx="7">
                  <c:v>4084.0</c:v>
                </c:pt>
                <c:pt idx="8">
                  <c:v>3727.0</c:v>
                </c:pt>
                <c:pt idx="9">
                  <c:v>5123.0</c:v>
                </c:pt>
                <c:pt idx="10">
                  <c:v>7368.0</c:v>
                </c:pt>
                <c:pt idx="11">
                  <c:v>2909.0</c:v>
                </c:pt>
                <c:pt idx="12">
                  <c:v>3189.0</c:v>
                </c:pt>
                <c:pt idx="13">
                  <c:v>3135.0</c:v>
                </c:pt>
                <c:pt idx="14">
                  <c:v>3291.0</c:v>
                </c:pt>
                <c:pt idx="15">
                  <c:v>2993.0</c:v>
                </c:pt>
                <c:pt idx="16">
                  <c:v>4062.0</c:v>
                </c:pt>
                <c:pt idx="17">
                  <c:v>3604.0</c:v>
                </c:pt>
                <c:pt idx="18">
                  <c:v>2939.0</c:v>
                </c:pt>
                <c:pt idx="19">
                  <c:v>3796.0</c:v>
                </c:pt>
                <c:pt idx="20">
                  <c:v>6280.0</c:v>
                </c:pt>
                <c:pt idx="21">
                  <c:v>3005.0</c:v>
                </c:pt>
                <c:pt idx="22">
                  <c:v>2690.0</c:v>
                </c:pt>
                <c:pt idx="23">
                  <c:v>3747.0</c:v>
                </c:pt>
                <c:pt idx="24">
                  <c:v>3592.0</c:v>
                </c:pt>
                <c:pt idx="25">
                  <c:v>2957.0</c:v>
                </c:pt>
                <c:pt idx="26">
                  <c:v>2804.0</c:v>
                </c:pt>
                <c:pt idx="27">
                  <c:v>3527.0</c:v>
                </c:pt>
                <c:pt idx="28">
                  <c:v>3220.0</c:v>
                </c:pt>
                <c:pt idx="29">
                  <c:v>3129.0</c:v>
                </c:pt>
                <c:pt idx="30">
                  <c:v>5462.0</c:v>
                </c:pt>
                <c:pt idx="31">
                  <c:v>3228.0</c:v>
                </c:pt>
                <c:pt idx="32">
                  <c:v>2579.0</c:v>
                </c:pt>
                <c:pt idx="33">
                  <c:v>3258.0</c:v>
                </c:pt>
                <c:pt idx="34">
                  <c:v>3521.0</c:v>
                </c:pt>
                <c:pt idx="35">
                  <c:v>2789.0</c:v>
                </c:pt>
                <c:pt idx="36">
                  <c:v>3363.0</c:v>
                </c:pt>
                <c:pt idx="37">
                  <c:v>2778.0</c:v>
                </c:pt>
                <c:pt idx="38">
                  <c:v>3573.0</c:v>
                </c:pt>
                <c:pt idx="39">
                  <c:v>3653.0</c:v>
                </c:pt>
                <c:pt idx="40">
                  <c:v>5918.0</c:v>
                </c:pt>
                <c:pt idx="41">
                  <c:v>3012.0</c:v>
                </c:pt>
                <c:pt idx="42">
                  <c:v>3231.0</c:v>
                </c:pt>
                <c:pt idx="43">
                  <c:v>3913.0</c:v>
                </c:pt>
                <c:pt idx="44">
                  <c:v>2941.0</c:v>
                </c:pt>
                <c:pt idx="45">
                  <c:v>2469.0</c:v>
                </c:pt>
                <c:pt idx="46">
                  <c:v>3430.0</c:v>
                </c:pt>
                <c:pt idx="47">
                  <c:v>3010.0</c:v>
                </c:pt>
                <c:pt idx="48">
                  <c:v>3451.0</c:v>
                </c:pt>
                <c:pt idx="49">
                  <c:v>3086.0</c:v>
                </c:pt>
                <c:pt idx="50">
                  <c:v>3444.0</c:v>
                </c:pt>
                <c:pt idx="51">
                  <c:v>3061.0</c:v>
                </c:pt>
                <c:pt idx="52">
                  <c:v>2658.0</c:v>
                </c:pt>
                <c:pt idx="53">
                  <c:v>3012.0</c:v>
                </c:pt>
                <c:pt idx="54">
                  <c:v>3136.0</c:v>
                </c:pt>
                <c:pt idx="55">
                  <c:v>2423.0</c:v>
                </c:pt>
                <c:pt idx="56">
                  <c:v>3890.0</c:v>
                </c:pt>
                <c:pt idx="57">
                  <c:v>2759.0</c:v>
                </c:pt>
                <c:pt idx="58">
                  <c:v>4124.0</c:v>
                </c:pt>
                <c:pt idx="59">
                  <c:v>3845.0</c:v>
                </c:pt>
                <c:pt idx="60">
                  <c:v>3886.0</c:v>
                </c:pt>
                <c:pt idx="61">
                  <c:v>3517.0</c:v>
                </c:pt>
                <c:pt idx="62">
                  <c:v>3426.0</c:v>
                </c:pt>
                <c:pt idx="63">
                  <c:v>3010.0</c:v>
                </c:pt>
                <c:pt idx="64">
                  <c:v>3765.0</c:v>
                </c:pt>
                <c:pt idx="65">
                  <c:v>3026.0</c:v>
                </c:pt>
                <c:pt idx="66">
                  <c:v>3308.0</c:v>
                </c:pt>
                <c:pt idx="67">
                  <c:v>2709.0</c:v>
                </c:pt>
                <c:pt idx="68">
                  <c:v>2598.0</c:v>
                </c:pt>
                <c:pt idx="69">
                  <c:v>2705.0</c:v>
                </c:pt>
                <c:pt idx="70">
                  <c:v>4160.0</c:v>
                </c:pt>
                <c:pt idx="71">
                  <c:v>3788.0</c:v>
                </c:pt>
                <c:pt idx="72">
                  <c:v>3242.0</c:v>
                </c:pt>
                <c:pt idx="73">
                  <c:v>3339.0</c:v>
                </c:pt>
                <c:pt idx="74">
                  <c:v>3533.0</c:v>
                </c:pt>
                <c:pt idx="75">
                  <c:v>3265.0</c:v>
                </c:pt>
                <c:pt idx="76">
                  <c:v>3337.0</c:v>
                </c:pt>
                <c:pt idx="77">
                  <c:v>2524.0</c:v>
                </c:pt>
                <c:pt idx="78">
                  <c:v>3406.0</c:v>
                </c:pt>
                <c:pt idx="79">
                  <c:v>3111.0</c:v>
                </c:pt>
                <c:pt idx="80">
                  <c:v>3139.0</c:v>
                </c:pt>
                <c:pt idx="81" formatCode="0">
                  <c:v>1.76225E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26391544"/>
        <c:axId val="-2026388584"/>
      </c:scatterChart>
      <c:valAx>
        <c:axId val="-2026391544"/>
        <c:scaling>
          <c:orientation val="minMax"/>
        </c:scaling>
        <c:delete val="0"/>
        <c:axPos val="b"/>
        <c:majorTickMark val="out"/>
        <c:minorTickMark val="none"/>
        <c:tickLblPos val="nextTo"/>
        <c:crossAx val="-2026388584"/>
        <c:crosses val="autoZero"/>
        <c:crossBetween val="midCat"/>
      </c:valAx>
      <c:valAx>
        <c:axId val="-2026388584"/>
        <c:scaling>
          <c:orientation val="minMax"/>
        </c:scaling>
        <c:delete val="0"/>
        <c:axPos val="l"/>
        <c:numFmt formatCode="0" sourceLinked="1"/>
        <c:majorTickMark val="out"/>
        <c:minorTickMark val="none"/>
        <c:tickLblPos val="nextTo"/>
        <c:crossAx val="-2026391544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110DA-BCE8-5747-B2DE-EEFE03F34484}" type="datetimeFigureOut">
              <a:rPr kumimoji="1" lang="ja-JP" altLang="en-US" smtClean="0"/>
              <a:t>20/01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7D495-BC76-3043-9727-3E02C42642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26550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110DA-BCE8-5747-B2DE-EEFE03F34484}" type="datetimeFigureOut">
              <a:rPr kumimoji="1" lang="ja-JP" altLang="en-US" smtClean="0"/>
              <a:t>20/01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7D495-BC76-3043-9727-3E02C42642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62090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110DA-BCE8-5747-B2DE-EEFE03F34484}" type="datetimeFigureOut">
              <a:rPr kumimoji="1" lang="ja-JP" altLang="en-US" smtClean="0"/>
              <a:t>20/01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7D495-BC76-3043-9727-3E02C42642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36793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110DA-BCE8-5747-B2DE-EEFE03F34484}" type="datetimeFigureOut">
              <a:rPr kumimoji="1" lang="ja-JP" altLang="en-US" smtClean="0"/>
              <a:t>20/01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7D495-BC76-3043-9727-3E02C42642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91958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110DA-BCE8-5747-B2DE-EEFE03F34484}" type="datetimeFigureOut">
              <a:rPr kumimoji="1" lang="ja-JP" altLang="en-US" smtClean="0"/>
              <a:t>20/01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7D495-BC76-3043-9727-3E02C42642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03926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110DA-BCE8-5747-B2DE-EEFE03F34484}" type="datetimeFigureOut">
              <a:rPr kumimoji="1" lang="ja-JP" altLang="en-US" smtClean="0"/>
              <a:t>20/01/1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7D495-BC76-3043-9727-3E02C42642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17953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110DA-BCE8-5747-B2DE-EEFE03F34484}" type="datetimeFigureOut">
              <a:rPr kumimoji="1" lang="ja-JP" altLang="en-US" smtClean="0"/>
              <a:t>20/01/1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7D495-BC76-3043-9727-3E02C42642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56980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110DA-BCE8-5747-B2DE-EEFE03F34484}" type="datetimeFigureOut">
              <a:rPr kumimoji="1" lang="ja-JP" altLang="en-US" smtClean="0"/>
              <a:t>20/01/1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7D495-BC76-3043-9727-3E02C42642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19093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110DA-BCE8-5747-B2DE-EEFE03F34484}" type="datetimeFigureOut">
              <a:rPr kumimoji="1" lang="ja-JP" altLang="en-US" smtClean="0"/>
              <a:t>20/01/1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7D495-BC76-3043-9727-3E02C42642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56062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110DA-BCE8-5747-B2DE-EEFE03F34484}" type="datetimeFigureOut">
              <a:rPr kumimoji="1" lang="ja-JP" altLang="en-US" smtClean="0"/>
              <a:t>20/01/1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7D495-BC76-3043-9727-3E02C42642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15161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110DA-BCE8-5747-B2DE-EEFE03F34484}" type="datetimeFigureOut">
              <a:rPr kumimoji="1" lang="ja-JP" altLang="en-US" smtClean="0"/>
              <a:t>20/01/1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7D495-BC76-3043-9727-3E02C42642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35821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0110DA-BCE8-5747-B2DE-EEFE03F34484}" type="datetimeFigureOut">
              <a:rPr kumimoji="1" lang="ja-JP" altLang="en-US" smtClean="0"/>
              <a:t>20/01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47D495-BC76-3043-9727-3E02C42642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56158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6" Type="http://schemas.openxmlformats.org/officeDocument/2006/relationships/chart" Target="../charts/chart5.xml"/><Relationship Id="rId7" Type="http://schemas.openxmlformats.org/officeDocument/2006/relationships/chart" Target="../charts/chart6.xml"/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11765672"/>
              </p:ext>
            </p:extLst>
          </p:nvPr>
        </p:nvGraphicFramePr>
        <p:xfrm>
          <a:off x="659231" y="638288"/>
          <a:ext cx="4009927" cy="19101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グラフ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82887977"/>
              </p:ext>
            </p:extLst>
          </p:nvPr>
        </p:nvGraphicFramePr>
        <p:xfrm>
          <a:off x="4699909" y="638288"/>
          <a:ext cx="4315522" cy="19101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グラフ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92230324"/>
              </p:ext>
            </p:extLst>
          </p:nvPr>
        </p:nvGraphicFramePr>
        <p:xfrm>
          <a:off x="638241" y="2548477"/>
          <a:ext cx="4030917" cy="18578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0" name="グラフ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35413304"/>
              </p:ext>
            </p:extLst>
          </p:nvPr>
        </p:nvGraphicFramePr>
        <p:xfrm>
          <a:off x="4669159" y="2485371"/>
          <a:ext cx="4430234" cy="19209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2" name="グラフ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16575586"/>
              </p:ext>
            </p:extLst>
          </p:nvPr>
        </p:nvGraphicFramePr>
        <p:xfrm>
          <a:off x="638241" y="4532272"/>
          <a:ext cx="4030917" cy="21727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3" name="グラフ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40244438"/>
              </p:ext>
            </p:extLst>
          </p:nvPr>
        </p:nvGraphicFramePr>
        <p:xfrm>
          <a:off x="4699909" y="4595380"/>
          <a:ext cx="4399484" cy="20991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6" name="テキスト ボックス 15"/>
          <p:cNvSpPr txBox="1"/>
          <p:nvPr/>
        </p:nvSpPr>
        <p:spPr>
          <a:xfrm>
            <a:off x="1317372" y="722463"/>
            <a:ext cx="8735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Z’: 0.86</a:t>
            </a:r>
            <a:endParaRPr kumimoji="1" lang="ja-JP" altLang="en-US" dirty="0"/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5381358" y="722463"/>
            <a:ext cx="8735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Z’: 0.71</a:t>
            </a:r>
            <a:endParaRPr kumimoji="1" lang="ja-JP" altLang="en-US" dirty="0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1235242" y="2584677"/>
            <a:ext cx="8735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Z’: 0.89</a:t>
            </a:r>
            <a:endParaRPr kumimoji="1" lang="ja-JP" altLang="en-US" dirty="0"/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5339508" y="2551015"/>
            <a:ext cx="8735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Z’: 0.92</a:t>
            </a:r>
            <a:endParaRPr kumimoji="1" lang="ja-JP" altLang="en-US" dirty="0"/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1235242" y="4645405"/>
            <a:ext cx="8735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Z’: 0.89</a:t>
            </a:r>
            <a:endParaRPr kumimoji="1" lang="ja-JP" altLang="en-US" dirty="0"/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5439432" y="4705455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Z’: 0.84</a:t>
            </a:r>
            <a:endParaRPr kumimoji="1" lang="ja-JP" altLang="en-US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xmlns="" id="{4170C558-5414-3245-9416-725E6DFF3E29}"/>
              </a:ext>
            </a:extLst>
          </p:cNvPr>
          <p:cNvSpPr txBox="1"/>
          <p:nvPr/>
        </p:nvSpPr>
        <p:spPr>
          <a:xfrm rot="16200000">
            <a:off x="-565010" y="1192793"/>
            <a:ext cx="217032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 sz="1200" b="0" i="0" u="none" strike="noStrike" kern="1200" baseline="0">
                <a:solidFill>
                  <a:prstClr val="black">
                    <a:lumMod val="65000"/>
                    <a:lumOff val="35000"/>
                  </a:prst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NFkB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activity</a:t>
            </a:r>
          </a:p>
          <a:p>
            <a:pPr algn="ctr">
              <a:defRPr sz="1200" b="0" i="0" u="none" strike="noStrike" kern="1200" baseline="0">
                <a:solidFill>
                  <a:prstClr val="black">
                    <a:lumMod val="65000"/>
                    <a:lumOff val="35000"/>
                  </a:prst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Relative light Units)</a:t>
            </a:r>
            <a:endParaRPr lang="ja-JP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xmlns="" id="{4170C558-5414-3245-9416-725E6DFF3E29}"/>
              </a:ext>
            </a:extLst>
          </p:cNvPr>
          <p:cNvSpPr txBox="1"/>
          <p:nvPr/>
        </p:nvSpPr>
        <p:spPr>
          <a:xfrm rot="16200000">
            <a:off x="-562032" y="3159433"/>
            <a:ext cx="217032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 sz="1200" b="0" i="0" u="none" strike="noStrike" kern="1200" baseline="0">
                <a:solidFill>
                  <a:prstClr val="black">
                    <a:lumMod val="65000"/>
                    <a:lumOff val="35000"/>
                  </a:prst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NFkB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activity</a:t>
            </a:r>
          </a:p>
          <a:p>
            <a:pPr algn="ctr">
              <a:defRPr sz="1200" b="0" i="0" u="none" strike="noStrike" kern="1200" baseline="0">
                <a:solidFill>
                  <a:prstClr val="black">
                    <a:lumMod val="65000"/>
                    <a:lumOff val="35000"/>
                  </a:prst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Relative light Units)</a:t>
            </a:r>
            <a:endParaRPr lang="ja-JP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xmlns="" id="{4170C558-5414-3245-9416-725E6DFF3E29}"/>
              </a:ext>
            </a:extLst>
          </p:cNvPr>
          <p:cNvSpPr txBox="1"/>
          <p:nvPr/>
        </p:nvSpPr>
        <p:spPr>
          <a:xfrm rot="16200000">
            <a:off x="-565844" y="5126990"/>
            <a:ext cx="217032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 sz="1200" b="0" i="0" u="none" strike="noStrike" kern="1200" baseline="0">
                <a:solidFill>
                  <a:prstClr val="black">
                    <a:lumMod val="65000"/>
                    <a:lumOff val="35000"/>
                  </a:prst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NFkB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activity</a:t>
            </a:r>
          </a:p>
          <a:p>
            <a:pPr algn="ctr">
              <a:defRPr sz="1200" b="0" i="0" u="none" strike="noStrike" kern="1200" baseline="0">
                <a:solidFill>
                  <a:prstClr val="black">
                    <a:lumMod val="65000"/>
                    <a:lumOff val="35000"/>
                  </a:prst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Relative light Units)</a:t>
            </a:r>
            <a:endParaRPr lang="ja-JP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2190928" y="268956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IL-18</a:t>
            </a:r>
            <a:endParaRPr kumimoji="1" lang="ja-JP" altLang="en-US" dirty="0"/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6646386" y="268956"/>
            <a:ext cx="5070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LPS</a:t>
            </a:r>
            <a:endParaRPr kumimoji="1" lang="ja-JP" altLang="en-US" dirty="0"/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1306877" y="976339"/>
            <a:ext cx="8288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late 1</a:t>
            </a:r>
            <a:endParaRPr kumimoji="1" lang="ja-JP" altLang="en-US" dirty="0"/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5376462" y="965843"/>
            <a:ext cx="8288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late 1</a:t>
            </a:r>
            <a:endParaRPr kumimoji="1" lang="ja-JP" altLang="en-US" dirty="0"/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1238008" y="2838553"/>
            <a:ext cx="8288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late 2</a:t>
            </a:r>
            <a:endParaRPr kumimoji="1" lang="ja-JP" altLang="en-US" dirty="0"/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5329013" y="2821823"/>
            <a:ext cx="8288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late 2</a:t>
            </a:r>
            <a:endParaRPr kumimoji="1" lang="ja-JP" altLang="en-US" dirty="0"/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1214252" y="4932105"/>
            <a:ext cx="8288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late 3</a:t>
            </a:r>
            <a:endParaRPr kumimoji="1" lang="ja-JP" altLang="en-US" dirty="0"/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5433533" y="4962257"/>
            <a:ext cx="8288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late 3</a:t>
            </a:r>
            <a:endParaRPr kumimoji="1" lang="ja-JP" altLang="en-US" dirty="0"/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3226714" y="-12026"/>
            <a:ext cx="28848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ynthetic compound library</a:t>
            </a:r>
            <a:endParaRPr kumimoji="1" lang="ja-JP" altLang="en-US" dirty="0"/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8031352" y="1633433"/>
            <a:ext cx="924293" cy="2570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solidFill>
                  <a:srgbClr val="3366FF"/>
                </a:solidFill>
              </a:rPr>
              <a:t>LPS (1ng/ml)</a:t>
            </a:r>
            <a:endParaRPr kumimoji="1" lang="ja-JP" altLang="en-US" sz="1200" dirty="0">
              <a:solidFill>
                <a:srgbClr val="3366FF"/>
              </a:solidFill>
            </a:endParaRPr>
          </a:p>
        </p:txBody>
      </p:sp>
      <p:cxnSp>
        <p:nvCxnSpPr>
          <p:cNvPr id="36" name="直線矢印コネクタ 35"/>
          <p:cNvCxnSpPr/>
          <p:nvPr/>
        </p:nvCxnSpPr>
        <p:spPr>
          <a:xfrm flipV="1">
            <a:off x="4161975" y="970885"/>
            <a:ext cx="0" cy="542045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7" name="テキスト ボックス 36"/>
          <p:cNvSpPr txBox="1"/>
          <p:nvPr/>
        </p:nvSpPr>
        <p:spPr>
          <a:xfrm>
            <a:off x="3681706" y="1504889"/>
            <a:ext cx="966462" cy="2570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solidFill>
                  <a:srgbClr val="FF0000"/>
                </a:solidFill>
              </a:rPr>
              <a:t>IL18 (</a:t>
            </a:r>
            <a:r>
              <a:rPr lang="en-US" altLang="ja-JP" sz="1200" dirty="0" smtClean="0">
                <a:solidFill>
                  <a:srgbClr val="FF0000"/>
                </a:solidFill>
              </a:rPr>
              <a:t>5</a:t>
            </a:r>
            <a:r>
              <a:rPr kumimoji="1" lang="en-US" altLang="ja-JP" sz="1200" dirty="0" smtClean="0">
                <a:solidFill>
                  <a:srgbClr val="FF0000"/>
                </a:solidFill>
              </a:rPr>
              <a:t>ng/ml)</a:t>
            </a:r>
            <a:endParaRPr kumimoji="1" lang="ja-JP" altLang="en-US" sz="1200" dirty="0">
              <a:solidFill>
                <a:srgbClr val="FF0000"/>
              </a:solidFill>
            </a:endParaRPr>
          </a:p>
        </p:txBody>
      </p:sp>
      <p:cxnSp>
        <p:nvCxnSpPr>
          <p:cNvPr id="38" name="直線矢印コネクタ 37"/>
          <p:cNvCxnSpPr/>
          <p:nvPr/>
        </p:nvCxnSpPr>
        <p:spPr>
          <a:xfrm flipV="1">
            <a:off x="8493499" y="1102291"/>
            <a:ext cx="0" cy="542045"/>
          </a:xfrm>
          <a:prstGeom prst="straightConnector1">
            <a:avLst/>
          </a:prstGeom>
          <a:ln>
            <a:solidFill>
              <a:srgbClr val="3366FF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9" name="テキスト ボックス 38"/>
          <p:cNvSpPr txBox="1"/>
          <p:nvPr/>
        </p:nvSpPr>
        <p:spPr>
          <a:xfrm>
            <a:off x="8103583" y="3381273"/>
            <a:ext cx="924293" cy="2570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solidFill>
                  <a:srgbClr val="3366FF"/>
                </a:solidFill>
              </a:rPr>
              <a:t>LPS (1ng/ml)</a:t>
            </a:r>
            <a:endParaRPr kumimoji="1" lang="ja-JP" altLang="en-US" sz="1200" dirty="0">
              <a:solidFill>
                <a:srgbClr val="3366FF"/>
              </a:solidFill>
            </a:endParaRPr>
          </a:p>
        </p:txBody>
      </p:sp>
      <p:cxnSp>
        <p:nvCxnSpPr>
          <p:cNvPr id="40" name="直線矢印コネクタ 39"/>
          <p:cNvCxnSpPr/>
          <p:nvPr/>
        </p:nvCxnSpPr>
        <p:spPr>
          <a:xfrm flipV="1">
            <a:off x="4160741" y="3012613"/>
            <a:ext cx="0" cy="542045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1" name="テキスト ボックス 40"/>
          <p:cNvSpPr txBox="1"/>
          <p:nvPr/>
        </p:nvSpPr>
        <p:spPr>
          <a:xfrm>
            <a:off x="3680472" y="3546617"/>
            <a:ext cx="966462" cy="2570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solidFill>
                  <a:srgbClr val="FF0000"/>
                </a:solidFill>
              </a:rPr>
              <a:t>IL18 (</a:t>
            </a:r>
            <a:r>
              <a:rPr lang="en-US" altLang="ja-JP" sz="1200" dirty="0" smtClean="0">
                <a:solidFill>
                  <a:srgbClr val="FF0000"/>
                </a:solidFill>
              </a:rPr>
              <a:t>5</a:t>
            </a:r>
            <a:r>
              <a:rPr kumimoji="1" lang="en-US" altLang="ja-JP" sz="1200" dirty="0" smtClean="0">
                <a:solidFill>
                  <a:srgbClr val="FF0000"/>
                </a:solidFill>
              </a:rPr>
              <a:t>ng/ml)</a:t>
            </a:r>
            <a:endParaRPr kumimoji="1" lang="ja-JP" altLang="en-US" sz="1200" dirty="0">
              <a:solidFill>
                <a:srgbClr val="FF0000"/>
              </a:solidFill>
            </a:endParaRPr>
          </a:p>
        </p:txBody>
      </p:sp>
      <p:cxnSp>
        <p:nvCxnSpPr>
          <p:cNvPr id="42" name="直線矢印コネクタ 41"/>
          <p:cNvCxnSpPr/>
          <p:nvPr/>
        </p:nvCxnSpPr>
        <p:spPr>
          <a:xfrm flipV="1">
            <a:off x="8565730" y="2850131"/>
            <a:ext cx="0" cy="542045"/>
          </a:xfrm>
          <a:prstGeom prst="straightConnector1">
            <a:avLst/>
          </a:prstGeom>
          <a:ln>
            <a:solidFill>
              <a:srgbClr val="3366FF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4" name="テキスト ボックス 43"/>
          <p:cNvSpPr txBox="1"/>
          <p:nvPr/>
        </p:nvSpPr>
        <p:spPr>
          <a:xfrm>
            <a:off x="8094144" y="5589605"/>
            <a:ext cx="924293" cy="2570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solidFill>
                  <a:srgbClr val="3366FF"/>
                </a:solidFill>
              </a:rPr>
              <a:t>LPS (1ng/ml)</a:t>
            </a:r>
            <a:endParaRPr kumimoji="1" lang="ja-JP" altLang="en-US" sz="1200" dirty="0">
              <a:solidFill>
                <a:srgbClr val="3366FF"/>
              </a:solidFill>
            </a:endParaRPr>
          </a:p>
        </p:txBody>
      </p:sp>
      <p:cxnSp>
        <p:nvCxnSpPr>
          <p:cNvPr id="45" name="直線矢印コネクタ 44"/>
          <p:cNvCxnSpPr/>
          <p:nvPr/>
        </p:nvCxnSpPr>
        <p:spPr>
          <a:xfrm flipV="1">
            <a:off x="4151302" y="5028849"/>
            <a:ext cx="0" cy="542045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6" name="テキスト ボックス 45"/>
          <p:cNvSpPr txBox="1"/>
          <p:nvPr/>
        </p:nvSpPr>
        <p:spPr>
          <a:xfrm>
            <a:off x="3671033" y="5562853"/>
            <a:ext cx="966462" cy="2570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solidFill>
                  <a:srgbClr val="FF0000"/>
                </a:solidFill>
              </a:rPr>
              <a:t>IL18 (</a:t>
            </a:r>
            <a:r>
              <a:rPr lang="en-US" altLang="ja-JP" sz="1200" dirty="0" smtClean="0">
                <a:solidFill>
                  <a:srgbClr val="FF0000"/>
                </a:solidFill>
              </a:rPr>
              <a:t>5</a:t>
            </a:r>
            <a:r>
              <a:rPr kumimoji="1" lang="en-US" altLang="ja-JP" sz="1200" dirty="0" smtClean="0">
                <a:solidFill>
                  <a:srgbClr val="FF0000"/>
                </a:solidFill>
              </a:rPr>
              <a:t>ng/ml)</a:t>
            </a:r>
            <a:endParaRPr kumimoji="1" lang="ja-JP" altLang="en-US" sz="1200" dirty="0">
              <a:solidFill>
                <a:srgbClr val="FF0000"/>
              </a:solidFill>
            </a:endParaRPr>
          </a:p>
        </p:txBody>
      </p:sp>
      <p:cxnSp>
        <p:nvCxnSpPr>
          <p:cNvPr id="47" name="直線矢印コネクタ 46"/>
          <p:cNvCxnSpPr/>
          <p:nvPr/>
        </p:nvCxnSpPr>
        <p:spPr>
          <a:xfrm flipV="1">
            <a:off x="8556291" y="5058463"/>
            <a:ext cx="0" cy="542045"/>
          </a:xfrm>
          <a:prstGeom prst="straightConnector1">
            <a:avLst/>
          </a:prstGeom>
          <a:ln>
            <a:solidFill>
              <a:srgbClr val="3366FF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8" name="テキスト ボックス 47"/>
          <p:cNvSpPr txBox="1"/>
          <p:nvPr/>
        </p:nvSpPr>
        <p:spPr>
          <a:xfrm>
            <a:off x="2135687" y="6600911"/>
            <a:ext cx="1072871" cy="2570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ompound No.</a:t>
            </a:r>
            <a:endParaRPr kumimoji="1" lang="ja-JP" altLang="en-US" sz="1200" dirty="0"/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6429169" y="6592392"/>
            <a:ext cx="1072871" cy="2570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ompound No.</a:t>
            </a:r>
            <a:endParaRPr kumimoji="1" lang="ja-JP" altLang="en-US" sz="1200" dirty="0"/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1370697" y="1677474"/>
            <a:ext cx="672365" cy="2570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 smtClean="0"/>
              <a:t>Vechicle</a:t>
            </a:r>
            <a:endParaRPr kumimoji="1" lang="ja-JP" altLang="en-US" sz="1200" dirty="0"/>
          </a:p>
        </p:txBody>
      </p:sp>
      <p:cxnSp>
        <p:nvCxnSpPr>
          <p:cNvPr id="51" name="直線矢印コネクタ 50"/>
          <p:cNvCxnSpPr/>
          <p:nvPr/>
        </p:nvCxnSpPr>
        <p:spPr>
          <a:xfrm flipH="1">
            <a:off x="1238009" y="1934563"/>
            <a:ext cx="277542" cy="274493"/>
          </a:xfrm>
          <a:prstGeom prst="straightConnector1">
            <a:avLst/>
          </a:prstGeom>
          <a:ln w="9525" cmpd="sng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5" name="テキスト ボックス 54"/>
          <p:cNvSpPr txBox="1"/>
          <p:nvPr/>
        </p:nvSpPr>
        <p:spPr>
          <a:xfrm>
            <a:off x="5500671" y="1633433"/>
            <a:ext cx="672365" cy="2570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 smtClean="0"/>
              <a:t>Vechicle</a:t>
            </a:r>
            <a:endParaRPr kumimoji="1" lang="ja-JP" altLang="en-US" sz="1200" dirty="0"/>
          </a:p>
        </p:txBody>
      </p:sp>
      <p:cxnSp>
        <p:nvCxnSpPr>
          <p:cNvPr id="56" name="直線矢印コネクタ 55"/>
          <p:cNvCxnSpPr/>
          <p:nvPr/>
        </p:nvCxnSpPr>
        <p:spPr>
          <a:xfrm flipH="1">
            <a:off x="5367983" y="1890522"/>
            <a:ext cx="277542" cy="274493"/>
          </a:xfrm>
          <a:prstGeom prst="straightConnector1">
            <a:avLst/>
          </a:prstGeom>
          <a:ln w="9525" cmpd="sng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9" name="テキスト ボックス 58"/>
          <p:cNvSpPr txBox="1"/>
          <p:nvPr/>
        </p:nvSpPr>
        <p:spPr>
          <a:xfrm>
            <a:off x="1388537" y="3426667"/>
            <a:ext cx="672365" cy="2570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 smtClean="0"/>
              <a:t>Vechicle</a:t>
            </a:r>
            <a:endParaRPr kumimoji="1" lang="ja-JP" altLang="en-US" sz="1200" dirty="0"/>
          </a:p>
        </p:txBody>
      </p:sp>
      <p:cxnSp>
        <p:nvCxnSpPr>
          <p:cNvPr id="60" name="直線矢印コネクタ 59"/>
          <p:cNvCxnSpPr/>
          <p:nvPr/>
        </p:nvCxnSpPr>
        <p:spPr>
          <a:xfrm flipH="1">
            <a:off x="1255849" y="3683756"/>
            <a:ext cx="277542" cy="274493"/>
          </a:xfrm>
          <a:prstGeom prst="straightConnector1">
            <a:avLst/>
          </a:prstGeom>
          <a:ln w="9525" cmpd="sng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1" name="テキスト ボックス 60"/>
          <p:cNvSpPr txBox="1"/>
          <p:nvPr/>
        </p:nvSpPr>
        <p:spPr>
          <a:xfrm>
            <a:off x="5518511" y="3478674"/>
            <a:ext cx="672365" cy="2570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 smtClean="0"/>
              <a:t>Vechicle</a:t>
            </a:r>
            <a:endParaRPr kumimoji="1" lang="ja-JP" altLang="en-US" sz="1200" dirty="0"/>
          </a:p>
        </p:txBody>
      </p:sp>
      <p:cxnSp>
        <p:nvCxnSpPr>
          <p:cNvPr id="62" name="直線矢印コネクタ 61"/>
          <p:cNvCxnSpPr/>
          <p:nvPr/>
        </p:nvCxnSpPr>
        <p:spPr>
          <a:xfrm flipH="1">
            <a:off x="5385823" y="3735763"/>
            <a:ext cx="277542" cy="274493"/>
          </a:xfrm>
          <a:prstGeom prst="straightConnector1">
            <a:avLst/>
          </a:prstGeom>
          <a:ln w="9525" cmpd="sng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3" name="テキスト ボックス 62"/>
          <p:cNvSpPr txBox="1"/>
          <p:nvPr/>
        </p:nvSpPr>
        <p:spPr>
          <a:xfrm>
            <a:off x="1382479" y="5718149"/>
            <a:ext cx="672365" cy="2570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 smtClean="0"/>
              <a:t>Vechicle</a:t>
            </a:r>
            <a:endParaRPr kumimoji="1" lang="ja-JP" altLang="en-US" sz="1200" dirty="0"/>
          </a:p>
        </p:txBody>
      </p:sp>
      <p:cxnSp>
        <p:nvCxnSpPr>
          <p:cNvPr id="64" name="直線矢印コネクタ 63"/>
          <p:cNvCxnSpPr/>
          <p:nvPr/>
        </p:nvCxnSpPr>
        <p:spPr>
          <a:xfrm flipH="1">
            <a:off x="1249791" y="5975238"/>
            <a:ext cx="277542" cy="274493"/>
          </a:xfrm>
          <a:prstGeom prst="straightConnector1">
            <a:avLst/>
          </a:prstGeom>
          <a:ln w="9525" cmpd="sng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5" name="テキスト ボックス 64"/>
          <p:cNvSpPr txBox="1"/>
          <p:nvPr/>
        </p:nvSpPr>
        <p:spPr>
          <a:xfrm>
            <a:off x="5512453" y="5770156"/>
            <a:ext cx="672365" cy="2570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 smtClean="0"/>
              <a:t>Vechicle</a:t>
            </a:r>
            <a:endParaRPr kumimoji="1" lang="ja-JP" altLang="en-US" sz="1200" dirty="0"/>
          </a:p>
        </p:txBody>
      </p:sp>
      <p:cxnSp>
        <p:nvCxnSpPr>
          <p:cNvPr id="66" name="直線矢印コネクタ 65"/>
          <p:cNvCxnSpPr/>
          <p:nvPr/>
        </p:nvCxnSpPr>
        <p:spPr>
          <a:xfrm flipH="1">
            <a:off x="5379765" y="6027245"/>
            <a:ext cx="277542" cy="274493"/>
          </a:xfrm>
          <a:prstGeom prst="straightConnector1">
            <a:avLst/>
          </a:prstGeom>
          <a:ln w="9525" cmpd="sng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63481257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4</TotalTime>
  <Words>112</Words>
  <Application>Microsoft Macintosh PowerPoint</Application>
  <PresentationFormat>画面に合わせる (4:3)</PresentationFormat>
  <Paragraphs>35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東京理科大学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朋 米沢</dc:creator>
  <cp:lastModifiedBy>朋 米沢</cp:lastModifiedBy>
  <cp:revision>12</cp:revision>
  <dcterms:created xsi:type="dcterms:W3CDTF">2020-01-09T17:55:07Z</dcterms:created>
  <dcterms:modified xsi:type="dcterms:W3CDTF">2020-01-09T22:29:22Z</dcterms:modified>
</cp:coreProperties>
</file>